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48756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79218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7441349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 userDrawn="1"/>
        </p:nvSpPr>
        <p:spPr>
          <a:xfrm>
            <a:off x="0" y="5"/>
            <a:ext cx="12192000" cy="653891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AU" sz="1800" dirty="0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en-US" dirty="0"/>
              <a:t>HMRI is a partnership between the University of Newcastle, Hunter New England Local Health District and the Community.</a:t>
            </a:r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2297494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92548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44927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33247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0389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67293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6082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7708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82907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E8B1B3-2EC6-451A-A9A8-2F49FC39631B}" type="datetimeFigureOut">
              <a:rPr lang="en-AU" smtClean="0"/>
              <a:t>17/01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50592-B122-4C8D-95D3-01381EA6FC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0723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microsoft.com/office/2007/relationships/hdphoto" Target="../media/hdphoto2.wdp"/><Relationship Id="rId4" Type="http://schemas.openxmlformats.org/officeDocument/2006/relationships/image" Target="../media/image3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Box 158"/>
          <p:cNvSpPr txBox="1">
            <a:spLocks noChangeArrowheads="1"/>
          </p:cNvSpPr>
          <p:nvPr/>
        </p:nvSpPr>
        <p:spPr bwMode="auto">
          <a:xfrm>
            <a:off x="2124786" y="4474271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 smtClean="0">
                <a:latin typeface="Arial" charset="0"/>
              </a:rPr>
              <a:t>25 – </a:t>
            </a:r>
            <a:endParaRPr lang="en-AU" altLang="en-US" sz="1050" dirty="0">
              <a:latin typeface="Arial" charset="0"/>
            </a:endParaRPr>
          </a:p>
        </p:txBody>
      </p:sp>
      <p:sp>
        <p:nvSpPr>
          <p:cNvPr id="109" name="TextBox 158"/>
          <p:cNvSpPr txBox="1">
            <a:spLocks noChangeArrowheads="1"/>
          </p:cNvSpPr>
          <p:nvPr/>
        </p:nvSpPr>
        <p:spPr bwMode="auto">
          <a:xfrm>
            <a:off x="2124786" y="4690469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>
                <a:latin typeface="Arial" charset="0"/>
              </a:rPr>
              <a:t>1</a:t>
            </a:r>
            <a:r>
              <a:rPr lang="en-AU" altLang="en-US" sz="1050" dirty="0" smtClean="0">
                <a:latin typeface="Arial" charset="0"/>
              </a:rPr>
              <a:t>5 – </a:t>
            </a:r>
            <a:endParaRPr lang="en-AU" altLang="en-US" sz="1050" dirty="0">
              <a:latin typeface="Arial" charset="0"/>
            </a:endParaRPr>
          </a:p>
        </p:txBody>
      </p:sp>
      <p:sp>
        <p:nvSpPr>
          <p:cNvPr id="110" name="TextBox 158"/>
          <p:cNvSpPr txBox="1">
            <a:spLocks noChangeArrowheads="1"/>
          </p:cNvSpPr>
          <p:nvPr/>
        </p:nvSpPr>
        <p:spPr bwMode="auto">
          <a:xfrm>
            <a:off x="2124786" y="3962977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 smtClean="0">
                <a:latin typeface="Arial" charset="0"/>
              </a:rPr>
              <a:t>37 – </a:t>
            </a:r>
            <a:endParaRPr lang="en-AU" altLang="en-US" sz="1050" dirty="0">
              <a:latin typeface="Arial" charset="0"/>
            </a:endParaRPr>
          </a:p>
        </p:txBody>
      </p:sp>
      <p:sp>
        <p:nvSpPr>
          <p:cNvPr id="111" name="TextBox 158"/>
          <p:cNvSpPr txBox="1">
            <a:spLocks noChangeArrowheads="1"/>
          </p:cNvSpPr>
          <p:nvPr/>
        </p:nvSpPr>
        <p:spPr bwMode="auto">
          <a:xfrm>
            <a:off x="2124786" y="3513052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 smtClean="0">
                <a:latin typeface="Arial" charset="0"/>
              </a:rPr>
              <a:t>50 – </a:t>
            </a:r>
            <a:endParaRPr lang="en-AU" altLang="en-US" sz="1050" dirty="0">
              <a:latin typeface="Arial" charset="0"/>
            </a:endParaRPr>
          </a:p>
        </p:txBody>
      </p:sp>
      <p:sp>
        <p:nvSpPr>
          <p:cNvPr id="112" name="TextBox 158"/>
          <p:cNvSpPr txBox="1">
            <a:spLocks noChangeArrowheads="1"/>
          </p:cNvSpPr>
          <p:nvPr/>
        </p:nvSpPr>
        <p:spPr bwMode="auto">
          <a:xfrm>
            <a:off x="2124786" y="2430023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 smtClean="0">
                <a:latin typeface="Arial" charset="0"/>
              </a:rPr>
              <a:t>100 – </a:t>
            </a:r>
            <a:endParaRPr lang="en-AU" altLang="en-US" sz="1050" dirty="0">
              <a:latin typeface="Arial" charset="0"/>
            </a:endParaRPr>
          </a:p>
        </p:txBody>
      </p:sp>
      <p:sp>
        <p:nvSpPr>
          <p:cNvPr id="113" name="TextBox 158"/>
          <p:cNvSpPr txBox="1">
            <a:spLocks noChangeArrowheads="1"/>
          </p:cNvSpPr>
          <p:nvPr/>
        </p:nvSpPr>
        <p:spPr bwMode="auto">
          <a:xfrm>
            <a:off x="2124786" y="5027352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 smtClean="0">
                <a:latin typeface="Arial" charset="0"/>
              </a:rPr>
              <a:t>10 – </a:t>
            </a:r>
            <a:endParaRPr lang="en-AU" altLang="en-US" sz="1050" dirty="0">
              <a:latin typeface="Arial" charset="0"/>
            </a:endParaRPr>
          </a:p>
        </p:txBody>
      </p:sp>
      <p:sp>
        <p:nvSpPr>
          <p:cNvPr id="114" name="TextBox 158"/>
          <p:cNvSpPr txBox="1">
            <a:spLocks noChangeArrowheads="1"/>
          </p:cNvSpPr>
          <p:nvPr/>
        </p:nvSpPr>
        <p:spPr bwMode="auto">
          <a:xfrm>
            <a:off x="2124786" y="2895242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 smtClean="0">
                <a:latin typeface="Arial" charset="0"/>
              </a:rPr>
              <a:t>75 – </a:t>
            </a:r>
            <a:endParaRPr lang="en-AU" altLang="en-US" sz="1050" dirty="0">
              <a:latin typeface="Arial" charset="0"/>
            </a:endParaRPr>
          </a:p>
        </p:txBody>
      </p:sp>
      <p:sp>
        <p:nvSpPr>
          <p:cNvPr id="115" name="TextBox 158"/>
          <p:cNvSpPr txBox="1">
            <a:spLocks noChangeArrowheads="1"/>
          </p:cNvSpPr>
          <p:nvPr/>
        </p:nvSpPr>
        <p:spPr bwMode="auto">
          <a:xfrm>
            <a:off x="2124786" y="2028974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 smtClean="0">
                <a:latin typeface="Arial" charset="0"/>
              </a:rPr>
              <a:t>125 – </a:t>
            </a:r>
            <a:endParaRPr lang="en-AU" altLang="en-US" sz="1050" dirty="0">
              <a:latin typeface="Arial" charset="0"/>
            </a:endParaRPr>
          </a:p>
        </p:txBody>
      </p:sp>
      <p:sp>
        <p:nvSpPr>
          <p:cNvPr id="116" name="TextBox 158"/>
          <p:cNvSpPr txBox="1">
            <a:spLocks noChangeArrowheads="1"/>
          </p:cNvSpPr>
          <p:nvPr/>
        </p:nvSpPr>
        <p:spPr bwMode="auto">
          <a:xfrm>
            <a:off x="2124786" y="1796365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 smtClean="0">
                <a:latin typeface="Arial" charset="0"/>
              </a:rPr>
              <a:t>150 – </a:t>
            </a:r>
            <a:endParaRPr lang="en-AU" altLang="en-US" sz="1050" dirty="0">
              <a:latin typeface="Arial" charset="0"/>
            </a:endParaRPr>
          </a:p>
        </p:txBody>
      </p:sp>
      <p:sp>
        <p:nvSpPr>
          <p:cNvPr id="117" name="TextBox 158"/>
          <p:cNvSpPr txBox="1">
            <a:spLocks noChangeArrowheads="1"/>
          </p:cNvSpPr>
          <p:nvPr/>
        </p:nvSpPr>
        <p:spPr bwMode="auto">
          <a:xfrm>
            <a:off x="2124786" y="1507073"/>
            <a:ext cx="868297" cy="2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>
                <a:latin typeface="Arial" charset="0"/>
              </a:rPr>
              <a:t>2</a:t>
            </a:r>
            <a:r>
              <a:rPr lang="en-AU" altLang="en-US" sz="1050" dirty="0" smtClean="0">
                <a:latin typeface="Arial" charset="0"/>
              </a:rPr>
              <a:t>50 – </a:t>
            </a:r>
            <a:endParaRPr lang="en-AU" altLang="en-US" sz="1050" dirty="0">
              <a:latin typeface="Arial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887579" y="557388"/>
            <a:ext cx="6230639" cy="5086471"/>
            <a:chOff x="1363578" y="557387"/>
            <a:chExt cx="6230639" cy="5086471"/>
          </a:xfrm>
        </p:grpSpPr>
        <p:grpSp>
          <p:nvGrpSpPr>
            <p:cNvPr id="46" name="Group 45"/>
            <p:cNvGrpSpPr/>
            <p:nvPr/>
          </p:nvGrpSpPr>
          <p:grpSpPr>
            <a:xfrm>
              <a:off x="1661586" y="5438654"/>
              <a:ext cx="1937551" cy="205204"/>
              <a:chOff x="2294381" y="6137947"/>
              <a:chExt cx="2016224" cy="205204"/>
            </a:xfrm>
          </p:grpSpPr>
          <p:cxnSp>
            <p:nvCxnSpPr>
              <p:cNvPr id="47" name="Straight Connector 46"/>
              <p:cNvCxnSpPr/>
              <p:nvPr/>
            </p:nvCxnSpPr>
            <p:spPr>
              <a:xfrm rot="16200000">
                <a:off x="4247054" y="6201499"/>
                <a:ext cx="12710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8" name="Group 47"/>
              <p:cNvGrpSpPr/>
              <p:nvPr/>
            </p:nvGrpSpPr>
            <p:grpSpPr>
              <a:xfrm>
                <a:off x="2294381" y="6137947"/>
                <a:ext cx="2016224" cy="205204"/>
                <a:chOff x="2294381" y="6137947"/>
                <a:chExt cx="2016224" cy="205204"/>
              </a:xfrm>
            </p:grpSpPr>
            <p:grpSp>
              <p:nvGrpSpPr>
                <p:cNvPr id="49" name="Group 48"/>
                <p:cNvGrpSpPr/>
                <p:nvPr/>
              </p:nvGrpSpPr>
              <p:grpSpPr>
                <a:xfrm>
                  <a:off x="2294381" y="6137947"/>
                  <a:ext cx="2016224" cy="127102"/>
                  <a:chOff x="2294381" y="6137947"/>
                  <a:chExt cx="2016224" cy="127102"/>
                </a:xfrm>
              </p:grpSpPr>
              <p:cxnSp>
                <p:nvCxnSpPr>
                  <p:cNvPr id="51" name="Straight Connector 50"/>
                  <p:cNvCxnSpPr/>
                  <p:nvPr/>
                </p:nvCxnSpPr>
                <p:spPr>
                  <a:xfrm>
                    <a:off x="2294381" y="6263422"/>
                    <a:ext cx="2016224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" name="Straight Connector 51"/>
                  <p:cNvCxnSpPr/>
                  <p:nvPr/>
                </p:nvCxnSpPr>
                <p:spPr>
                  <a:xfrm rot="16200000">
                    <a:off x="2230830" y="6201498"/>
                    <a:ext cx="127102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0" name="TextBox 49"/>
                <p:cNvSpPr txBox="1"/>
                <p:nvPr/>
              </p:nvSpPr>
              <p:spPr>
                <a:xfrm>
                  <a:off x="2776867" y="6158485"/>
                  <a:ext cx="1051252" cy="18466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AU" sz="1200" dirty="0"/>
                    <a:t>Total plasma </a:t>
                  </a:r>
                </a:p>
              </p:txBody>
            </p:sp>
          </p:grpSp>
        </p:grpSp>
        <p:grpSp>
          <p:nvGrpSpPr>
            <p:cNvPr id="53" name="Group 52"/>
            <p:cNvGrpSpPr/>
            <p:nvPr/>
          </p:nvGrpSpPr>
          <p:grpSpPr>
            <a:xfrm>
              <a:off x="3632382" y="5438654"/>
              <a:ext cx="1937551" cy="205204"/>
              <a:chOff x="2294381" y="6137947"/>
              <a:chExt cx="2016224" cy="205204"/>
            </a:xfrm>
          </p:grpSpPr>
          <p:cxnSp>
            <p:nvCxnSpPr>
              <p:cNvPr id="54" name="Straight Connector 53"/>
              <p:cNvCxnSpPr/>
              <p:nvPr/>
            </p:nvCxnSpPr>
            <p:spPr>
              <a:xfrm rot="16200000">
                <a:off x="4247054" y="6201499"/>
                <a:ext cx="12710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5" name="Group 54"/>
              <p:cNvGrpSpPr/>
              <p:nvPr/>
            </p:nvGrpSpPr>
            <p:grpSpPr>
              <a:xfrm>
                <a:off x="2294381" y="6137947"/>
                <a:ext cx="2016224" cy="205204"/>
                <a:chOff x="2294381" y="6137947"/>
                <a:chExt cx="2016224" cy="205204"/>
              </a:xfrm>
            </p:grpSpPr>
            <p:grpSp>
              <p:nvGrpSpPr>
                <p:cNvPr id="56" name="Group 55"/>
                <p:cNvGrpSpPr/>
                <p:nvPr/>
              </p:nvGrpSpPr>
              <p:grpSpPr>
                <a:xfrm>
                  <a:off x="2294381" y="6137947"/>
                  <a:ext cx="2016224" cy="127102"/>
                  <a:chOff x="2294381" y="6137947"/>
                  <a:chExt cx="2016224" cy="127102"/>
                </a:xfrm>
              </p:grpSpPr>
              <p:cxnSp>
                <p:nvCxnSpPr>
                  <p:cNvPr id="58" name="Straight Connector 57"/>
                  <p:cNvCxnSpPr/>
                  <p:nvPr/>
                </p:nvCxnSpPr>
                <p:spPr>
                  <a:xfrm>
                    <a:off x="2294381" y="6263422"/>
                    <a:ext cx="2016224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Straight Connector 58"/>
                  <p:cNvCxnSpPr/>
                  <p:nvPr/>
                </p:nvCxnSpPr>
                <p:spPr>
                  <a:xfrm rot="16200000">
                    <a:off x="2230830" y="6201498"/>
                    <a:ext cx="127102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7" name="TextBox 56"/>
                <p:cNvSpPr txBox="1"/>
                <p:nvPr/>
              </p:nvSpPr>
              <p:spPr>
                <a:xfrm>
                  <a:off x="2776867" y="6158485"/>
                  <a:ext cx="1051252" cy="18466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AU" sz="1200" dirty="0"/>
                    <a:t>Albumin / IgG</a:t>
                  </a:r>
                </a:p>
              </p:txBody>
            </p:sp>
          </p:grpSp>
        </p:grpSp>
        <p:grpSp>
          <p:nvGrpSpPr>
            <p:cNvPr id="60" name="Group 59"/>
            <p:cNvGrpSpPr/>
            <p:nvPr/>
          </p:nvGrpSpPr>
          <p:grpSpPr>
            <a:xfrm>
              <a:off x="5603177" y="5438653"/>
              <a:ext cx="1937551" cy="205204"/>
              <a:chOff x="2294381" y="6137947"/>
              <a:chExt cx="2016224" cy="205204"/>
            </a:xfrm>
          </p:grpSpPr>
          <p:cxnSp>
            <p:nvCxnSpPr>
              <p:cNvPr id="61" name="Straight Connector 60"/>
              <p:cNvCxnSpPr/>
              <p:nvPr/>
            </p:nvCxnSpPr>
            <p:spPr>
              <a:xfrm rot="16200000">
                <a:off x="4247054" y="6201499"/>
                <a:ext cx="12710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2" name="Group 61"/>
              <p:cNvGrpSpPr/>
              <p:nvPr/>
            </p:nvGrpSpPr>
            <p:grpSpPr>
              <a:xfrm>
                <a:off x="2294381" y="6137947"/>
                <a:ext cx="2016224" cy="205204"/>
                <a:chOff x="2294381" y="6137947"/>
                <a:chExt cx="2016224" cy="205204"/>
              </a:xfrm>
            </p:grpSpPr>
            <p:grpSp>
              <p:nvGrpSpPr>
                <p:cNvPr id="63" name="Group 62"/>
                <p:cNvGrpSpPr/>
                <p:nvPr/>
              </p:nvGrpSpPr>
              <p:grpSpPr>
                <a:xfrm>
                  <a:off x="2294381" y="6137947"/>
                  <a:ext cx="2016224" cy="127102"/>
                  <a:chOff x="2294381" y="6137947"/>
                  <a:chExt cx="2016224" cy="127102"/>
                </a:xfrm>
              </p:grpSpPr>
              <p:cxnSp>
                <p:nvCxnSpPr>
                  <p:cNvPr id="65" name="Straight Connector 64"/>
                  <p:cNvCxnSpPr/>
                  <p:nvPr/>
                </p:nvCxnSpPr>
                <p:spPr>
                  <a:xfrm>
                    <a:off x="2294381" y="6263422"/>
                    <a:ext cx="2016224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" name="Straight Connector 65"/>
                  <p:cNvCxnSpPr/>
                  <p:nvPr/>
                </p:nvCxnSpPr>
                <p:spPr>
                  <a:xfrm rot="16200000">
                    <a:off x="2230830" y="6201498"/>
                    <a:ext cx="127102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4" name="TextBox 63"/>
                <p:cNvSpPr txBox="1"/>
                <p:nvPr/>
              </p:nvSpPr>
              <p:spPr>
                <a:xfrm>
                  <a:off x="2950557" y="6158485"/>
                  <a:ext cx="703871" cy="18466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AU" sz="1200" dirty="0"/>
                    <a:t>Depleted</a:t>
                  </a:r>
                </a:p>
              </p:txBody>
            </p:sp>
          </p:grpSp>
        </p:grpSp>
        <p:pic>
          <p:nvPicPr>
            <p:cNvPr id="69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59"/>
            <a:stretch/>
          </p:blipFill>
          <p:spPr bwMode="auto">
            <a:xfrm>
              <a:off x="1363578" y="1501983"/>
              <a:ext cx="6229627" cy="38957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grpSp>
          <p:nvGrpSpPr>
            <p:cNvPr id="4" name="Group 3"/>
            <p:cNvGrpSpPr/>
            <p:nvPr/>
          </p:nvGrpSpPr>
          <p:grpSpPr>
            <a:xfrm>
              <a:off x="1550342" y="557387"/>
              <a:ext cx="6043875" cy="1002115"/>
              <a:chOff x="1550342" y="598331"/>
              <a:chExt cx="6043875" cy="1002115"/>
            </a:xfrm>
          </p:grpSpPr>
          <p:sp>
            <p:nvSpPr>
              <p:cNvPr id="71" name="TextBox 70"/>
              <p:cNvSpPr txBox="1"/>
              <p:nvPr/>
            </p:nvSpPr>
            <p:spPr>
              <a:xfrm rot="16200000">
                <a:off x="1279519" y="1064239"/>
                <a:ext cx="7878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re-op  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 rot="16200000">
                <a:off x="1558129" y="1086463"/>
                <a:ext cx="743415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ost-op </a:t>
                </a: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 rot="16200000">
                <a:off x="1769929" y="1090686"/>
                <a:ext cx="751861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re-op  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 rot="16200000">
                <a:off x="2014249" y="1068458"/>
                <a:ext cx="796316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ost-op 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 rot="16200000">
                <a:off x="2290669" y="1087044"/>
                <a:ext cx="760308" cy="2450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re-op  </a:t>
                </a: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 rot="16200000">
                <a:off x="2518305" y="1068459"/>
                <a:ext cx="796315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ost-op  </a:t>
                </a: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 rot="16200000">
                <a:off x="2795303" y="1094909"/>
                <a:ext cx="760307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re-op </a:t>
                </a: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 rot="16200000">
                <a:off x="3039624" y="1072682"/>
                <a:ext cx="804759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ost-op  </a:t>
                </a: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1564031" y="598331"/>
                <a:ext cx="10168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/>
                  <a:t>EDTA</a:t>
                </a:r>
                <a:r>
                  <a:rPr lang="en-AU" sz="1200" u="sng" dirty="0"/>
                  <a:t>    </a:t>
                </a:r>
              </a:p>
            </p:txBody>
          </p:sp>
          <p:cxnSp>
            <p:nvCxnSpPr>
              <p:cNvPr id="81" name="Straight Connector 80"/>
              <p:cNvCxnSpPr/>
              <p:nvPr/>
            </p:nvCxnSpPr>
            <p:spPr>
              <a:xfrm>
                <a:off x="1616541" y="878812"/>
                <a:ext cx="9189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TextBox 81"/>
              <p:cNvSpPr txBox="1"/>
              <p:nvPr/>
            </p:nvSpPr>
            <p:spPr>
              <a:xfrm>
                <a:off x="2548959" y="600603"/>
                <a:ext cx="10168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/>
                  <a:t>BCT</a:t>
                </a:r>
                <a:endParaRPr lang="en-AU" sz="1200" u="sng" dirty="0"/>
              </a:p>
            </p:txBody>
          </p:sp>
          <p:cxnSp>
            <p:nvCxnSpPr>
              <p:cNvPr id="83" name="Straight Connector 82"/>
              <p:cNvCxnSpPr/>
              <p:nvPr/>
            </p:nvCxnSpPr>
            <p:spPr>
              <a:xfrm>
                <a:off x="2601469" y="878812"/>
                <a:ext cx="9189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/>
              <p:cNvSpPr txBox="1"/>
              <p:nvPr/>
            </p:nvSpPr>
            <p:spPr>
              <a:xfrm rot="16200000">
                <a:off x="3315343" y="1066511"/>
                <a:ext cx="7878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re-op  </a:t>
                </a: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 rot="16200000">
                <a:off x="3593953" y="1088735"/>
                <a:ext cx="743415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ost-op </a:t>
                </a: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 rot="16200000">
                <a:off x="3805753" y="1092958"/>
                <a:ext cx="751861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re-op  </a:t>
                </a: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 rot="16200000">
                <a:off x="4050073" y="1070730"/>
                <a:ext cx="796316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ost-op </a:t>
                </a: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 rot="16200000">
                <a:off x="4326493" y="1089316"/>
                <a:ext cx="760308" cy="2450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re-op  </a:t>
                </a: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 rot="16200000">
                <a:off x="4554129" y="1070731"/>
                <a:ext cx="796315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ost-op  </a:t>
                </a: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 rot="16200000">
                <a:off x="4831127" y="1097181"/>
                <a:ext cx="760307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re-op </a:t>
                </a: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 rot="16200000">
                <a:off x="5075448" y="1074954"/>
                <a:ext cx="804759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ost-op  </a:t>
                </a: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3599855" y="600603"/>
                <a:ext cx="10168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/>
                  <a:t>EDTA</a:t>
                </a:r>
                <a:r>
                  <a:rPr lang="en-AU" sz="1200" u="sng" dirty="0"/>
                  <a:t>    </a:t>
                </a:r>
              </a:p>
            </p:txBody>
          </p:sp>
          <p:cxnSp>
            <p:nvCxnSpPr>
              <p:cNvPr id="93" name="Straight Connector 92"/>
              <p:cNvCxnSpPr/>
              <p:nvPr/>
            </p:nvCxnSpPr>
            <p:spPr>
              <a:xfrm>
                <a:off x="3652365" y="878812"/>
                <a:ext cx="9189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TextBox 93"/>
              <p:cNvSpPr txBox="1"/>
              <p:nvPr/>
            </p:nvSpPr>
            <p:spPr>
              <a:xfrm>
                <a:off x="4584783" y="602875"/>
                <a:ext cx="10168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/>
                  <a:t>BCT</a:t>
                </a:r>
                <a:endParaRPr lang="en-AU" sz="1200" u="sng" dirty="0"/>
              </a:p>
            </p:txBody>
          </p:sp>
          <p:cxnSp>
            <p:nvCxnSpPr>
              <p:cNvPr id="95" name="Straight Connector 94"/>
              <p:cNvCxnSpPr/>
              <p:nvPr/>
            </p:nvCxnSpPr>
            <p:spPr>
              <a:xfrm>
                <a:off x="4637293" y="878812"/>
                <a:ext cx="9189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95"/>
              <p:cNvSpPr txBox="1"/>
              <p:nvPr/>
            </p:nvSpPr>
            <p:spPr>
              <a:xfrm rot="16200000">
                <a:off x="5307951" y="1066511"/>
                <a:ext cx="7878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re-op  </a:t>
                </a: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 rot="16200000">
                <a:off x="5586561" y="1088735"/>
                <a:ext cx="743415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ost-op </a:t>
                </a: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 rot="16200000">
                <a:off x="5798361" y="1092958"/>
                <a:ext cx="751861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re-op  </a:t>
                </a: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 rot="16200000">
                <a:off x="6042681" y="1070730"/>
                <a:ext cx="796316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ost-op </a:t>
                </a: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 rot="16200000">
                <a:off x="6319101" y="1089316"/>
                <a:ext cx="760308" cy="2450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re-op  </a:t>
                </a: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 rot="16200000">
                <a:off x="6546737" y="1070731"/>
                <a:ext cx="796315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A Post-op  </a:t>
                </a: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 rot="16200000">
                <a:off x="6823735" y="1097181"/>
                <a:ext cx="760307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re-op </a:t>
                </a: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 rot="16200000">
                <a:off x="7068056" y="1074954"/>
                <a:ext cx="804759" cy="2462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0" dirty="0"/>
                  <a:t>B Post-op  </a:t>
                </a: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5592463" y="600603"/>
                <a:ext cx="10168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/>
                  <a:t>EDTA</a:t>
                </a:r>
                <a:r>
                  <a:rPr lang="en-AU" sz="1200" u="sng" dirty="0"/>
                  <a:t>    </a:t>
                </a:r>
              </a:p>
            </p:txBody>
          </p:sp>
          <p:cxnSp>
            <p:nvCxnSpPr>
              <p:cNvPr id="105" name="Straight Connector 104"/>
              <p:cNvCxnSpPr/>
              <p:nvPr/>
            </p:nvCxnSpPr>
            <p:spPr>
              <a:xfrm>
                <a:off x="5644973" y="878812"/>
                <a:ext cx="9189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TextBox 105"/>
              <p:cNvSpPr txBox="1"/>
              <p:nvPr/>
            </p:nvSpPr>
            <p:spPr>
              <a:xfrm>
                <a:off x="6577391" y="602875"/>
                <a:ext cx="10168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/>
                  <a:t>BCT</a:t>
                </a:r>
                <a:endParaRPr lang="en-AU" sz="1200" u="sng" dirty="0"/>
              </a:p>
            </p:txBody>
          </p:sp>
          <p:cxnSp>
            <p:nvCxnSpPr>
              <p:cNvPr id="107" name="Straight Connector 106"/>
              <p:cNvCxnSpPr/>
              <p:nvPr/>
            </p:nvCxnSpPr>
            <p:spPr>
              <a:xfrm>
                <a:off x="6629901" y="878812"/>
                <a:ext cx="9189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08" name="TextBox 113"/>
          <p:cNvSpPr txBox="1">
            <a:spLocks noChangeArrowheads="1"/>
          </p:cNvSpPr>
          <p:nvPr/>
        </p:nvSpPr>
        <p:spPr bwMode="auto">
          <a:xfrm rot="16200000">
            <a:off x="1799690" y="3176939"/>
            <a:ext cx="1178982" cy="233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dirty="0">
                <a:latin typeface="Arial" charset="0"/>
              </a:rPr>
              <a:t>kDa  </a:t>
            </a:r>
          </a:p>
        </p:txBody>
      </p:sp>
      <p:sp>
        <p:nvSpPr>
          <p:cNvPr id="118" name="TextBox 113"/>
          <p:cNvSpPr txBox="1">
            <a:spLocks noChangeArrowheads="1"/>
          </p:cNvSpPr>
          <p:nvPr/>
        </p:nvSpPr>
        <p:spPr bwMode="auto">
          <a:xfrm>
            <a:off x="2846181" y="1482761"/>
            <a:ext cx="229638" cy="233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b="1" dirty="0" smtClean="0">
                <a:latin typeface="Arial" charset="0"/>
              </a:rPr>
              <a:t>A  </a:t>
            </a:r>
            <a:endParaRPr lang="en-AU" altLang="en-US" sz="1050" b="1" dirty="0">
              <a:latin typeface="Arial" charset="0"/>
            </a:endParaRPr>
          </a:p>
        </p:txBody>
      </p:sp>
      <p:sp>
        <p:nvSpPr>
          <p:cNvPr id="119" name="TextBox 113"/>
          <p:cNvSpPr txBox="1">
            <a:spLocks noChangeArrowheads="1"/>
          </p:cNvSpPr>
          <p:nvPr/>
        </p:nvSpPr>
        <p:spPr bwMode="auto">
          <a:xfrm>
            <a:off x="4995810" y="1482761"/>
            <a:ext cx="229638" cy="233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b="1" dirty="0" smtClean="0">
                <a:latin typeface="Arial" charset="0"/>
              </a:rPr>
              <a:t>B  </a:t>
            </a:r>
            <a:endParaRPr lang="en-AU" altLang="en-US" sz="1050" b="1" dirty="0">
              <a:latin typeface="Arial" charset="0"/>
            </a:endParaRPr>
          </a:p>
        </p:txBody>
      </p:sp>
      <p:sp>
        <p:nvSpPr>
          <p:cNvPr id="120" name="TextBox 113"/>
          <p:cNvSpPr txBox="1">
            <a:spLocks noChangeArrowheads="1"/>
          </p:cNvSpPr>
          <p:nvPr/>
        </p:nvSpPr>
        <p:spPr bwMode="auto">
          <a:xfrm>
            <a:off x="7021357" y="1482761"/>
            <a:ext cx="229638" cy="233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lnSpc>
                <a:spcPts val="1100"/>
              </a:lnSpc>
              <a:spcBef>
                <a:spcPct val="0"/>
              </a:spcBef>
              <a:buFontTx/>
              <a:buNone/>
            </a:pPr>
            <a:r>
              <a:rPr lang="en-AU" altLang="en-US" sz="1050" b="1" dirty="0" smtClean="0">
                <a:latin typeface="Arial" charset="0"/>
              </a:rPr>
              <a:t>C  </a:t>
            </a:r>
            <a:endParaRPr lang="en-AU" altLang="en-US" sz="1050" b="1" dirty="0">
              <a:latin typeface="Arial" charset="0"/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0" y="6596390"/>
            <a:ext cx="193193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1:</a:t>
            </a:r>
            <a:endParaRPr lang="en-AU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0553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Rectangle 33"/>
          <p:cNvSpPr/>
          <p:nvPr/>
        </p:nvSpPr>
        <p:spPr>
          <a:xfrm>
            <a:off x="-40650" y="6596390"/>
            <a:ext cx="193193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2: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1754467" y="867503"/>
            <a:ext cx="8683066" cy="5122995"/>
            <a:chOff x="1561078" y="335144"/>
            <a:chExt cx="8683066" cy="5122995"/>
          </a:xfrm>
        </p:grpSpPr>
        <p:grpSp>
          <p:nvGrpSpPr>
            <p:cNvPr id="29" name="Group 28"/>
            <p:cNvGrpSpPr/>
            <p:nvPr/>
          </p:nvGrpSpPr>
          <p:grpSpPr>
            <a:xfrm>
              <a:off x="1973331" y="449541"/>
              <a:ext cx="3904434" cy="2043356"/>
              <a:chOff x="179512" y="401904"/>
              <a:chExt cx="4392488" cy="2307016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179512" y="401904"/>
                <a:ext cx="4278188" cy="2218279"/>
                <a:chOff x="179512" y="401904"/>
                <a:chExt cx="4278188" cy="2218279"/>
              </a:xfrm>
            </p:grpSpPr>
            <p:pic>
              <p:nvPicPr>
                <p:cNvPr id="2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84000"/>
                          </a14:imgEffect>
                          <a14:imgEffect>
                            <a14:saturation sat="33000"/>
                          </a14:imgEffect>
                          <a14:imgEffect>
                            <a14:brightnessContrast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70" t="2024" r="2064" b="7943"/>
                <a:stretch/>
              </p:blipFill>
              <p:spPr bwMode="auto">
                <a:xfrm>
                  <a:off x="179512" y="722965"/>
                  <a:ext cx="4278188" cy="18972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" name="TextBox 2"/>
                <p:cNvSpPr txBox="1"/>
                <p:nvPr/>
              </p:nvSpPr>
              <p:spPr>
                <a:xfrm>
                  <a:off x="1035437" y="401904"/>
                  <a:ext cx="1080120" cy="3127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12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CT</a:t>
                  </a:r>
                </a:p>
              </p:txBody>
            </p:sp>
          </p:grpSp>
          <p:cxnSp>
            <p:nvCxnSpPr>
              <p:cNvPr id="10" name="Straight Arrow Connector 9"/>
              <p:cNvCxnSpPr/>
              <p:nvPr/>
            </p:nvCxnSpPr>
            <p:spPr>
              <a:xfrm flipV="1">
                <a:off x="179512" y="493401"/>
                <a:ext cx="0" cy="221551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Arrow Connector 11"/>
              <p:cNvCxnSpPr/>
              <p:nvPr/>
            </p:nvCxnSpPr>
            <p:spPr>
              <a:xfrm>
                <a:off x="179512" y="2708920"/>
                <a:ext cx="439248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 29"/>
            <p:cNvGrpSpPr/>
            <p:nvPr/>
          </p:nvGrpSpPr>
          <p:grpSpPr>
            <a:xfrm>
              <a:off x="1971121" y="2930406"/>
              <a:ext cx="3908854" cy="2177432"/>
              <a:chOff x="179512" y="2914824"/>
              <a:chExt cx="4397461" cy="2458392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179512" y="2914824"/>
                <a:ext cx="4397461" cy="2352084"/>
                <a:chOff x="174539" y="2387908"/>
                <a:chExt cx="4397461" cy="2352084"/>
              </a:xfrm>
            </p:grpSpPr>
            <p:pic>
              <p:nvPicPr>
                <p:cNvPr id="1026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61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032" t="8975" r="2041" b="10390"/>
                <a:stretch/>
              </p:blipFill>
              <p:spPr bwMode="auto">
                <a:xfrm>
                  <a:off x="174539" y="2708920"/>
                  <a:ext cx="4397461" cy="2031072"/>
                </a:xfrm>
                <a:prstGeom prst="rect">
                  <a:avLst/>
                </a:prstGeom>
                <a:noFill/>
                <a:ln w="12700">
                  <a:noFill/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" name="TextBox 4"/>
                <p:cNvSpPr txBox="1"/>
                <p:nvPr/>
              </p:nvSpPr>
              <p:spPr>
                <a:xfrm>
                  <a:off x="1110643" y="2387908"/>
                  <a:ext cx="1080120" cy="3127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12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DTA</a:t>
                  </a:r>
                </a:p>
              </p:txBody>
            </p:sp>
          </p:grpSp>
          <p:cxnSp>
            <p:nvCxnSpPr>
              <p:cNvPr id="16" name="Straight Arrow Connector 15"/>
              <p:cNvCxnSpPr/>
              <p:nvPr/>
            </p:nvCxnSpPr>
            <p:spPr>
              <a:xfrm flipV="1">
                <a:off x="179512" y="3157697"/>
                <a:ext cx="0" cy="221551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Arrow Connector 16"/>
              <p:cNvCxnSpPr/>
              <p:nvPr/>
            </p:nvCxnSpPr>
            <p:spPr>
              <a:xfrm>
                <a:off x="179512" y="5373216"/>
                <a:ext cx="439248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Group 14"/>
            <p:cNvGrpSpPr/>
            <p:nvPr/>
          </p:nvGrpSpPr>
          <p:grpSpPr>
            <a:xfrm>
              <a:off x="6168085" y="530581"/>
              <a:ext cx="4076059" cy="1962316"/>
              <a:chOff x="4666954" y="260648"/>
              <a:chExt cx="4585566" cy="2520281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6">
                <a:grayscl/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4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66954" y="260648"/>
                <a:ext cx="4477046" cy="24482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18" name="Straight Arrow Connector 17"/>
              <p:cNvCxnSpPr/>
              <p:nvPr/>
            </p:nvCxnSpPr>
            <p:spPr>
              <a:xfrm flipV="1">
                <a:off x="4666954" y="260648"/>
                <a:ext cx="0" cy="252028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/>
              <p:cNvCxnSpPr/>
              <p:nvPr/>
            </p:nvCxnSpPr>
            <p:spPr>
              <a:xfrm>
                <a:off x="4666954" y="2780928"/>
                <a:ext cx="4585566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Group 19"/>
            <p:cNvGrpSpPr/>
            <p:nvPr/>
          </p:nvGrpSpPr>
          <p:grpSpPr>
            <a:xfrm>
              <a:off x="6189928" y="3145522"/>
              <a:ext cx="4032372" cy="1962316"/>
              <a:chOff x="4644094" y="2852936"/>
              <a:chExt cx="4536418" cy="2520281"/>
            </a:xfrm>
          </p:grpSpPr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 rotWithShape="1">
              <a:blip r:embed="rId8">
                <a:grayscl/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6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70"/>
              <a:stretch/>
            </p:blipFill>
            <p:spPr bwMode="auto">
              <a:xfrm>
                <a:off x="4656866" y="2936393"/>
                <a:ext cx="4490002" cy="24368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26" name="Straight Arrow Connector 25"/>
              <p:cNvCxnSpPr/>
              <p:nvPr/>
            </p:nvCxnSpPr>
            <p:spPr>
              <a:xfrm flipV="1">
                <a:off x="4644094" y="2852936"/>
                <a:ext cx="0" cy="252028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/>
              <p:cNvCxnSpPr/>
              <p:nvPr/>
            </p:nvCxnSpPr>
            <p:spPr>
              <a:xfrm>
                <a:off x="4644094" y="5373216"/>
                <a:ext cx="4536418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/>
            <p:cNvSpPr txBox="1"/>
            <p:nvPr/>
          </p:nvSpPr>
          <p:spPr>
            <a:xfrm>
              <a:off x="7066609" y="2918944"/>
              <a:ext cx="9601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MT2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066609" y="335144"/>
              <a:ext cx="9601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MT1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2389378" y="5181140"/>
              <a:ext cx="7352907" cy="276999"/>
              <a:chOff x="2389378" y="5155262"/>
              <a:chExt cx="7352907" cy="276999"/>
            </a:xfrm>
          </p:grpSpPr>
          <p:sp>
            <p:nvSpPr>
              <p:cNvPr id="31" name="TextBox 30"/>
              <p:cNvSpPr txBox="1"/>
              <p:nvPr/>
            </p:nvSpPr>
            <p:spPr>
              <a:xfrm>
                <a:off x="6669944" y="5155262"/>
                <a:ext cx="307234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 (min)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389378" y="5155262"/>
                <a:ext cx="307234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 (min)</a:t>
                </a: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1614289" y="816030"/>
              <a:ext cx="278580" cy="3851165"/>
              <a:chOff x="1605663" y="816030"/>
              <a:chExt cx="278580" cy="3851165"/>
            </a:xfrm>
          </p:grpSpPr>
          <p:sp>
            <p:nvSpPr>
              <p:cNvPr id="32" name="TextBox 31"/>
              <p:cNvSpPr txBox="1"/>
              <p:nvPr/>
            </p:nvSpPr>
            <p:spPr>
              <a:xfrm rot="16200000">
                <a:off x="1097672" y="1325602"/>
                <a:ext cx="1296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bundance 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 rot="16200000">
                <a:off x="1096091" y="3880623"/>
                <a:ext cx="1296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bundance </a:t>
                </a:r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>
              <a:off x="1561078" y="335144"/>
              <a:ext cx="3153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577250" y="2918944"/>
              <a:ext cx="3153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897730" y="2918944"/>
              <a:ext cx="3153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924618" y="335144"/>
              <a:ext cx="3153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cxnSp>
          <p:nvCxnSpPr>
            <p:cNvPr id="8" name="Straight Connector 7"/>
            <p:cNvCxnSpPr/>
            <p:nvPr/>
          </p:nvCxnSpPr>
          <p:spPr>
            <a:xfrm flipH="1">
              <a:off x="3303437" y="740458"/>
              <a:ext cx="1" cy="168866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 flipH="1">
              <a:off x="3307247" y="3396028"/>
              <a:ext cx="1" cy="168866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H="1">
              <a:off x="7536347" y="755698"/>
              <a:ext cx="1" cy="168866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H="1">
              <a:off x="7540157" y="3411268"/>
              <a:ext cx="1" cy="168866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Group 6"/>
            <p:cNvGrpSpPr/>
            <p:nvPr/>
          </p:nvGrpSpPr>
          <p:grpSpPr>
            <a:xfrm>
              <a:off x="2389378" y="2581720"/>
              <a:ext cx="7352907" cy="276999"/>
              <a:chOff x="2541778" y="2581720"/>
              <a:chExt cx="7352907" cy="276999"/>
            </a:xfrm>
          </p:grpSpPr>
          <p:sp>
            <p:nvSpPr>
              <p:cNvPr id="48" name="TextBox 47"/>
              <p:cNvSpPr txBox="1"/>
              <p:nvPr/>
            </p:nvSpPr>
            <p:spPr>
              <a:xfrm>
                <a:off x="6822344" y="2581720"/>
                <a:ext cx="307234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 (min)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2541778" y="2581720"/>
                <a:ext cx="307234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 (min)</a:t>
                </a:r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5855602" y="816030"/>
              <a:ext cx="278580" cy="3851165"/>
              <a:chOff x="1605663" y="816030"/>
              <a:chExt cx="278580" cy="3851165"/>
            </a:xfrm>
          </p:grpSpPr>
          <p:sp>
            <p:nvSpPr>
              <p:cNvPr id="51" name="TextBox 50"/>
              <p:cNvSpPr txBox="1"/>
              <p:nvPr/>
            </p:nvSpPr>
            <p:spPr>
              <a:xfrm rot="16200000">
                <a:off x="1097672" y="1325602"/>
                <a:ext cx="1296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bundance 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 rot="16200000">
                <a:off x="1096091" y="3880623"/>
                <a:ext cx="1296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bundance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195101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91944" y="1450185"/>
            <a:ext cx="374448" cy="276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165000" y="1438812"/>
            <a:ext cx="374448" cy="276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091944" y="4284186"/>
            <a:ext cx="374448" cy="276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7837516"/>
              </p:ext>
            </p:extLst>
          </p:nvPr>
        </p:nvGraphicFramePr>
        <p:xfrm>
          <a:off x="3355595" y="4415284"/>
          <a:ext cx="5805182" cy="1594485"/>
        </p:xfrm>
        <a:graphic>
          <a:graphicData uri="http://schemas.openxmlformats.org/drawingml/2006/table">
            <a:tbl>
              <a:tblPr/>
              <a:tblGrid>
                <a:gridCol w="649531">
                  <a:extLst>
                    <a:ext uri="{9D8B030D-6E8A-4147-A177-3AD203B41FA5}">
                      <a16:colId xmlns:a16="http://schemas.microsoft.com/office/drawing/2014/main" val="1677226056"/>
                    </a:ext>
                  </a:extLst>
                </a:gridCol>
                <a:gridCol w="2936419">
                  <a:extLst>
                    <a:ext uri="{9D8B030D-6E8A-4147-A177-3AD203B41FA5}">
                      <a16:colId xmlns:a16="http://schemas.microsoft.com/office/drawing/2014/main" val="1423735729"/>
                    </a:ext>
                  </a:extLst>
                </a:gridCol>
                <a:gridCol w="554808">
                  <a:extLst>
                    <a:ext uri="{9D8B030D-6E8A-4147-A177-3AD203B41FA5}">
                      <a16:colId xmlns:a16="http://schemas.microsoft.com/office/drawing/2014/main" val="1193582688"/>
                    </a:ext>
                  </a:extLst>
                </a:gridCol>
                <a:gridCol w="554808">
                  <a:extLst>
                    <a:ext uri="{9D8B030D-6E8A-4147-A177-3AD203B41FA5}">
                      <a16:colId xmlns:a16="http://schemas.microsoft.com/office/drawing/2014/main" val="3692025833"/>
                    </a:ext>
                  </a:extLst>
                </a:gridCol>
                <a:gridCol w="554808">
                  <a:extLst>
                    <a:ext uri="{9D8B030D-6E8A-4147-A177-3AD203B41FA5}">
                      <a16:colId xmlns:a16="http://schemas.microsoft.com/office/drawing/2014/main" val="373093111"/>
                    </a:ext>
                  </a:extLst>
                </a:gridCol>
                <a:gridCol w="554808">
                  <a:extLst>
                    <a:ext uri="{9D8B030D-6E8A-4147-A177-3AD203B41FA5}">
                      <a16:colId xmlns:a16="http://schemas.microsoft.com/office/drawing/2014/main" val="2602349098"/>
                    </a:ext>
                  </a:extLst>
                </a:gridCol>
              </a:tblGrid>
              <a:tr h="32389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 Nam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tein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 Pre / Post -op </a:t>
                      </a:r>
                      <a:r>
                        <a:rPr lang="en-AU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 Pre / Post -op</a:t>
                      </a:r>
                    </a:p>
                    <a:p>
                      <a:pPr algn="ctr" rtl="0" fontAlgn="ctr"/>
                      <a:r>
                        <a:rPr lang="en-AU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DTA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B Pre / Post -op B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B Pre / Post -op EDTA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9983728"/>
                  </a:ext>
                </a:extLst>
              </a:tr>
              <a:tr h="1322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MA3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maphorin-3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B9B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9E9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7B7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8779478"/>
                  </a:ext>
                </a:extLst>
              </a:tr>
              <a:tr h="1322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HPR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3 ubiquitin-protein ligase SHPR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B8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7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9A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9A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8714122"/>
                  </a:ext>
                </a:extLst>
              </a:tr>
              <a:tr h="1322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C1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ructural maintenance of chromosomes protein 1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E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D4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FA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A9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2771955"/>
                  </a:ext>
                </a:extLst>
              </a:tr>
              <a:tr h="1322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lsol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CA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BA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CB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88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0942955"/>
                  </a:ext>
                </a:extLst>
              </a:tr>
              <a:tr h="1322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MR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yotubularin-related protein 13-Phosph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6B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87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2A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1629552"/>
                  </a:ext>
                </a:extLst>
              </a:tr>
              <a:tr h="1322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NF8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Zinc finger protein 8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D4A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DE0B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E4C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D0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5759875"/>
                  </a:ext>
                </a:extLst>
              </a:tr>
              <a:tr h="1322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aptoglobi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C17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D39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C17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BB86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6259555"/>
                  </a:ext>
                </a:extLst>
              </a:tr>
              <a:tr h="1322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MB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MS-binding protein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BD6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CF9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CE9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DCB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6052682"/>
                  </a:ext>
                </a:extLst>
              </a:tr>
            </a:tbl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9896890"/>
              </p:ext>
            </p:extLst>
          </p:nvPr>
        </p:nvGraphicFramePr>
        <p:xfrm>
          <a:off x="2959931" y="1125600"/>
          <a:ext cx="6574143" cy="33788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r:id="rId3" imgW="5800781" imgH="2981432" progId="">
                  <p:embed/>
                </p:oleObj>
              </mc:Choice>
              <mc:Fallback>
                <p:oleObj r:id="rId3" imgW="5800781" imgH="2981432" progId="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59931" y="1125600"/>
                        <a:ext cx="6574143" cy="33788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Rectangle 10"/>
          <p:cNvSpPr/>
          <p:nvPr/>
        </p:nvSpPr>
        <p:spPr>
          <a:xfrm>
            <a:off x="-40650" y="6596390"/>
            <a:ext cx="193193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3: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48431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33</Words>
  <Application>Microsoft Office PowerPoint</Application>
  <PresentationFormat>Widescreen</PresentationFormat>
  <Paragraphs>12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The University of Newcastl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 Dun</dc:creator>
  <cp:lastModifiedBy>Matt Dun</cp:lastModifiedBy>
  <cp:revision>7</cp:revision>
  <dcterms:created xsi:type="dcterms:W3CDTF">2017-07-27T00:41:47Z</dcterms:created>
  <dcterms:modified xsi:type="dcterms:W3CDTF">2018-01-17T02:35:22Z</dcterms:modified>
</cp:coreProperties>
</file>